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85" r:id="rId3"/>
  </p:sldIdLst>
  <p:sldSz cx="6858000" cy="9144000" type="screen4x3"/>
  <p:notesSz cx="6888163" cy="100187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976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27" autoAdjust="0"/>
    <p:restoredTop sz="96781" autoAdjust="0"/>
  </p:normalViewPr>
  <p:slideViewPr>
    <p:cSldViewPr showGuides="1">
      <p:cViewPr varScale="1">
        <p:scale>
          <a:sx n="81" d="100"/>
          <a:sy n="81" d="100"/>
        </p:scale>
        <p:origin x="-3720" y="-84"/>
      </p:cViewPr>
      <p:guideLst>
        <p:guide orient="horz" pos="2976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>
      <p:cViewPr varScale="1">
        <p:scale>
          <a:sx n="51" d="100"/>
          <a:sy n="51" d="100"/>
        </p:scale>
        <p:origin x="2656" y="4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5282" cy="501444"/>
          </a:xfrm>
          <a:prstGeom prst="rect">
            <a:avLst/>
          </a:prstGeom>
        </p:spPr>
        <p:txBody>
          <a:bodyPr vert="horz" lIns="91418" tIns="45709" rIns="91418" bIns="45709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901344" y="0"/>
            <a:ext cx="2985282" cy="501444"/>
          </a:xfrm>
          <a:prstGeom prst="rect">
            <a:avLst/>
          </a:prstGeom>
        </p:spPr>
        <p:txBody>
          <a:bodyPr vert="horz" lIns="91418" tIns="45709" rIns="91418" bIns="45709" rtlCol="0"/>
          <a:lstStyle>
            <a:lvl1pPr algn="r">
              <a:defRPr sz="1200"/>
            </a:lvl1pPr>
          </a:lstStyle>
          <a:p>
            <a:fld id="{B354C057-AFC4-44EE-A134-DA7A71FCE3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36763" y="752475"/>
            <a:ext cx="2814637" cy="3756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8" tIns="45709" rIns="91418" bIns="45709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8202" y="4758639"/>
            <a:ext cx="5511762" cy="4507912"/>
          </a:xfrm>
          <a:prstGeom prst="rect">
            <a:avLst/>
          </a:prstGeom>
        </p:spPr>
        <p:txBody>
          <a:bodyPr vert="horz" lIns="91418" tIns="45709" rIns="91418" bIns="45709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515577"/>
            <a:ext cx="2985282" cy="501444"/>
          </a:xfrm>
          <a:prstGeom prst="rect">
            <a:avLst/>
          </a:prstGeom>
        </p:spPr>
        <p:txBody>
          <a:bodyPr vert="horz" lIns="91418" tIns="45709" rIns="91418" bIns="45709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901344" y="9515577"/>
            <a:ext cx="2985282" cy="501444"/>
          </a:xfrm>
          <a:prstGeom prst="rect">
            <a:avLst/>
          </a:prstGeom>
        </p:spPr>
        <p:txBody>
          <a:bodyPr vert="horz" lIns="91418" tIns="45709" rIns="91418" bIns="45709" rtlCol="0" anchor="b"/>
          <a:lstStyle>
            <a:lvl1pPr algn="r">
              <a:defRPr sz="1200"/>
            </a:lvl1pPr>
          </a:lstStyle>
          <a:p>
            <a:fld id="{AFFDF8A8-496D-4E63-A052-E8E13708C0C0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5392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FDF8A8-496D-4E63-A052-E8E13708C0C0}" type="slidenum">
              <a:rPr lang="de-DE" smtClean="0"/>
              <a:pPr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3051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7376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2530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7841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5329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7995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5114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6714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2749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0015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5943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8927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E7F1DE-22B2-4315-AED0-84AE1B70E102}" type="datetimeFigureOut">
              <a:rPr lang="de-DE" smtClean="0"/>
              <a:pPr/>
              <a:t>18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4A602-D766-441D-AD23-737A904A3D1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3464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/>
          <p:cNvSpPr txBox="1"/>
          <p:nvPr/>
        </p:nvSpPr>
        <p:spPr>
          <a:xfrm>
            <a:off x="492743" y="3962400"/>
            <a:ext cx="598425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lative increase of bone mineral density (BMD) in lumbar vertebral bodies [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3=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 (100%), L4 = HA/BMP; L5 = HA] of groups injected with BMP- 2 (A) or GDF-5 (B). ### P &lt; 0.001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##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 ≤ 0.01, # P ≤ 0.05 for HA/BMP compared to non-injected control; and +++ P &lt; 0.001, ++ P ≤ 0.01, +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 ≤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5 for HA/BMP compared to HA. Please note: The linear mixed effects model was used to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alyze global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ffects and overall interactions of the main effects treatment (group), time point (time), BMP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ose 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ose), and distance from the injection channel (area); subsequently, the non-parametric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ltigrou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ruskall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Walli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two-sided Wilcoxon tests were applied for the comparison of paired samples with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ne grou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and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ultigrou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riedman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two-sided Mann-Whitney U-tests for statistical evaluati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f difference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etween groups with the above-mentioned significance levels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" y="304800"/>
            <a:ext cx="652272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04311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Textfeld 105"/>
          <p:cNvSpPr txBox="1"/>
          <p:nvPr/>
        </p:nvSpPr>
        <p:spPr>
          <a:xfrm>
            <a:off x="162019" y="8112259"/>
            <a:ext cx="647889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Depiction of one representative of several islets of hyaline cartilage as a sig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f  early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chondral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ossification in paraffin sections of lumbar vertebral bodies at 3 months after injection of HA particle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L5 = HA; 1 µg BMP-2 group; A, B); and almost complete transformation of the hyaline cartilage at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9 month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fter injection of HA particles (L5 = HA; 1 µg BMP-2 group; C, D) or BMP- 2-coated particles (L4 =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A/BMP-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 10 µg; E).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08" y="53347"/>
            <a:ext cx="6675120" cy="8058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7162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0</Words>
  <Application>Microsoft Office PowerPoint</Application>
  <PresentationFormat>Bildschirmpräsentation (4:3)</PresentationFormat>
  <Paragraphs>3</Paragraphs>
  <Slides>2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inne, Raimund</dc:creator>
  <cp:lastModifiedBy>Huber, Rene Dr.</cp:lastModifiedBy>
  <cp:revision>502</cp:revision>
  <cp:lastPrinted>2021-12-15T16:26:42Z</cp:lastPrinted>
  <dcterms:created xsi:type="dcterms:W3CDTF">2017-07-27T07:50:17Z</dcterms:created>
  <dcterms:modified xsi:type="dcterms:W3CDTF">2022-02-18T21:28:12Z</dcterms:modified>
</cp:coreProperties>
</file>